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78688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9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Gemmink et al (2020) Diabetologia DOI 10.1007/s00125-020-05170-z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keletal muscle lipid metabolism: acute exercise and endurance training effec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3BF1D30-C513-4F39-99C5-C15F9DC1E1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3187" y="836712"/>
            <a:ext cx="6777626" cy="4979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emmink</a:t>
            </a:r>
            <a:r>
              <a:rPr lang="en-GB" dirty="0"/>
              <a:t> et al (2020) Diabetologia DOI 10.1007/s00125-020-05170-z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iver lipid metabolism: acute exercise and endurance training effect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B4448A8-6741-4B6E-9BE2-A5083B8A61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7311" y="661562"/>
            <a:ext cx="6209378" cy="5258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186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103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4</cp:revision>
  <dcterms:created xsi:type="dcterms:W3CDTF">2016-06-15T12:53:43Z</dcterms:created>
  <dcterms:modified xsi:type="dcterms:W3CDTF">2020-05-19T18:25:32Z</dcterms:modified>
</cp:coreProperties>
</file>